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13320713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54" autoAdjust="0"/>
    <p:restoredTop sz="74059" autoAdjust="0"/>
  </p:normalViewPr>
  <p:slideViewPr>
    <p:cSldViewPr snapToGrid="0">
      <p:cViewPr varScale="1">
        <p:scale>
          <a:sx n="55" d="100"/>
          <a:sy n="55" d="100"/>
        </p:scale>
        <p:origin x="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E91ACD-5DDA-45D0-82F3-7C8EEDAF3228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33388" y="1143000"/>
            <a:ext cx="599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F8692D-15B4-42EA-B8CD-ABDB21DC5B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897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F8692D-15B4-42EA-B8CD-ABDB21DC5B77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8801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33388" y="1143000"/>
            <a:ext cx="5991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F8692D-15B4-42EA-B8CD-ABDB21DC5B77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474059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33388" y="1143000"/>
            <a:ext cx="59912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FF8692D-15B4-42EA-B8CD-ABDB21DC5B77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62685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65089" y="1122363"/>
            <a:ext cx="9990535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5089" y="3602038"/>
            <a:ext cx="9990535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9816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7726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32635" y="365125"/>
            <a:ext cx="2872279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5799" y="365125"/>
            <a:ext cx="8450327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8959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0418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8861" y="1709739"/>
            <a:ext cx="1148911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861" y="4589464"/>
            <a:ext cx="1148911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5041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5799" y="1825625"/>
            <a:ext cx="5661303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43611" y="1825625"/>
            <a:ext cx="5661303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3983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365126"/>
            <a:ext cx="1148911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7535" y="1681163"/>
            <a:ext cx="563528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7535" y="2505075"/>
            <a:ext cx="5635285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43611" y="1681163"/>
            <a:ext cx="566303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43611" y="2505075"/>
            <a:ext cx="566303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4967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0631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8787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5" y="457200"/>
            <a:ext cx="429627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63038" y="987426"/>
            <a:ext cx="674361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5" y="2057400"/>
            <a:ext cx="429627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8256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5" y="457200"/>
            <a:ext cx="429627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63038" y="987426"/>
            <a:ext cx="674361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5" y="2057400"/>
            <a:ext cx="429627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0202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5799" y="365126"/>
            <a:ext cx="1148911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5799" y="1825625"/>
            <a:ext cx="1148911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5799" y="6356351"/>
            <a:ext cx="299716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9304F3-F0AC-45F3-8FCC-B5887EF507BA}" type="datetimeFigureOut">
              <a:rPr lang="en-GB" smtClean="0"/>
              <a:t>18/09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12486" y="6356351"/>
            <a:ext cx="4495741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07754" y="6356351"/>
            <a:ext cx="299716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A8B38-0641-4DC2-BE52-536084E5448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6756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6CDA6E-AD46-9504-E836-E96B30A265F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IN" sz="6000" dirty="0">
                <a:latin typeface="Arial" panose="020B0604020202020204" pitchFamily="34" charset="0"/>
                <a:cs typeface="Arial" panose="020B0604020202020204" pitchFamily="34" charset="0"/>
              </a:rPr>
              <a:t>Western blots (uncut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308869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37EC0C-B7D4-795A-27A0-E108E59055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Figure 3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6565367-7E60-2C39-00C2-411A902760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0937" y="1883265"/>
            <a:ext cx="3514725" cy="14097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E52AC08-4227-9024-528E-A51EFB967B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8835" y="3621579"/>
            <a:ext cx="3800475" cy="17621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4B72369-E983-F6FB-252A-A4A0F8F85F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62196" y="2968751"/>
            <a:ext cx="3870979" cy="7484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D5CC371D-202B-C8AD-C867-87BA39AFA88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92674" y="4486391"/>
            <a:ext cx="3935363" cy="15532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A6A37D3-A09F-94AD-927D-3CD1CB42F42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55742" y="1883265"/>
            <a:ext cx="3734169" cy="9818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8D7F2BC9-76C8-41C0-1F4A-3826EAEE485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20029" y="2987038"/>
            <a:ext cx="4096321" cy="7001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825A65AC-34BF-B435-4900-697D36D1549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944669" y="4504060"/>
            <a:ext cx="3935364" cy="14164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515EF739-BC6F-A15E-44F9-C98ED1BF7711}"/>
              </a:ext>
            </a:extLst>
          </p:cNvPr>
          <p:cNvSpPr txBox="1"/>
          <p:nvPr/>
        </p:nvSpPr>
        <p:spPr>
          <a:xfrm flipH="1">
            <a:off x="8920027" y="5049737"/>
            <a:ext cx="9427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ottom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-4EBP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E83AB09-1951-038A-819D-39ED8D3CDCAB}"/>
              </a:ext>
            </a:extLst>
          </p:cNvPr>
          <p:cNvSpPr txBox="1"/>
          <p:nvPr/>
        </p:nvSpPr>
        <p:spPr>
          <a:xfrm flipH="1">
            <a:off x="8920027" y="3058689"/>
            <a:ext cx="9362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p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3A4AB46-A688-3683-BC16-FAB6AC623F37}"/>
              </a:ext>
            </a:extLst>
          </p:cNvPr>
          <p:cNvSpPr txBox="1"/>
          <p:nvPr/>
        </p:nvSpPr>
        <p:spPr>
          <a:xfrm flipH="1">
            <a:off x="218833" y="2401219"/>
            <a:ext cx="9427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-VASP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34BCCF6-A416-822D-5AD8-F49B69E5C98F}"/>
              </a:ext>
            </a:extLst>
          </p:cNvPr>
          <p:cNvSpPr txBox="1"/>
          <p:nvPr/>
        </p:nvSpPr>
        <p:spPr>
          <a:xfrm flipH="1">
            <a:off x="173762" y="4378275"/>
            <a:ext cx="9427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ob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s β-actin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526DA3F-2D81-EB13-D4A2-EC43FD23E259}"/>
              </a:ext>
            </a:extLst>
          </p:cNvPr>
          <p:cNvSpPr txBox="1"/>
          <p:nvPr/>
        </p:nvSpPr>
        <p:spPr>
          <a:xfrm flipH="1">
            <a:off x="4518143" y="2186824"/>
            <a:ext cx="9427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p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-AKT-473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A7777AF-68C8-58D0-A97A-FA6F1B85912B}"/>
              </a:ext>
            </a:extLst>
          </p:cNvPr>
          <p:cNvSpPr txBox="1"/>
          <p:nvPr/>
        </p:nvSpPr>
        <p:spPr>
          <a:xfrm flipH="1">
            <a:off x="4484400" y="3189954"/>
            <a:ext cx="12306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ob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s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-S6K1-371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9415320-5497-9CEB-549E-4A1BE656D708}"/>
              </a:ext>
            </a:extLst>
          </p:cNvPr>
          <p:cNvSpPr txBox="1"/>
          <p:nvPr/>
        </p:nvSpPr>
        <p:spPr>
          <a:xfrm flipH="1">
            <a:off x="4484400" y="4474364"/>
            <a:ext cx="12306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otto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ob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s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796B8277-7DC8-0909-3C53-A23037B904B6}"/>
              </a:ext>
            </a:extLst>
          </p:cNvPr>
          <p:cNvSpPr/>
          <p:nvPr/>
        </p:nvSpPr>
        <p:spPr>
          <a:xfrm>
            <a:off x="48330" y="1536192"/>
            <a:ext cx="4218869" cy="4852416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5D20A27-9BC3-E4D5-3EB4-5BEA5D2EFD81}"/>
              </a:ext>
            </a:extLst>
          </p:cNvPr>
          <p:cNvSpPr/>
          <p:nvPr/>
        </p:nvSpPr>
        <p:spPr>
          <a:xfrm>
            <a:off x="4461917" y="1536192"/>
            <a:ext cx="4218869" cy="4852416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2D43673-29FA-C981-1E08-4D9F31CFA765}"/>
              </a:ext>
            </a:extLst>
          </p:cNvPr>
          <p:cNvSpPr/>
          <p:nvPr/>
        </p:nvSpPr>
        <p:spPr>
          <a:xfrm>
            <a:off x="8850632" y="1536192"/>
            <a:ext cx="4218869" cy="4852416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06665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66D290-971C-40D7-81F1-B095F963FF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Figure 3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2C7B89A-62C9-9F76-CF04-71B6C61F814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049"/>
          <a:stretch/>
        </p:blipFill>
        <p:spPr>
          <a:xfrm>
            <a:off x="915799" y="1739256"/>
            <a:ext cx="5009763" cy="139065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B4F5775-6BFC-F745-7E28-8C5E9DF0C2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68107" y="4818190"/>
            <a:ext cx="5343525" cy="16097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796B414-2F56-4A4C-6910-D080ED1D6FA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68107" y="2955277"/>
            <a:ext cx="5210175" cy="17811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B09B3EF-6B80-3E98-AE2E-DEBF0D7B77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01061" y="1116533"/>
            <a:ext cx="3981450" cy="14954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3E29D9AB-417D-79CD-D1C6-E53BF06831FF}"/>
              </a:ext>
            </a:extLst>
          </p:cNvPr>
          <p:cNvSpPr txBox="1"/>
          <p:nvPr/>
        </p:nvSpPr>
        <p:spPr>
          <a:xfrm flipH="1">
            <a:off x="284598" y="2369611"/>
            <a:ext cx="9427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-VASP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CF53516-8950-E2BA-7E85-C2841909AB48}"/>
              </a:ext>
            </a:extLst>
          </p:cNvPr>
          <p:cNvSpPr txBox="1"/>
          <p:nvPr/>
        </p:nvSpPr>
        <p:spPr>
          <a:xfrm flipH="1">
            <a:off x="714870" y="4523643"/>
            <a:ext cx="9427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β-actin 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obed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A0FC136-9C00-6275-FD90-9609A3E292E6}"/>
              </a:ext>
            </a:extLst>
          </p:cNvPr>
          <p:cNvSpPr txBox="1"/>
          <p:nvPr/>
        </p:nvSpPr>
        <p:spPr>
          <a:xfrm flipH="1">
            <a:off x="6859061" y="1959600"/>
            <a:ext cx="9427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p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D88BDFC-DC01-B775-3666-AE39915B3DC8}"/>
              </a:ext>
            </a:extLst>
          </p:cNvPr>
          <p:cNvSpPr txBox="1"/>
          <p:nvPr/>
        </p:nvSpPr>
        <p:spPr>
          <a:xfrm flipH="1">
            <a:off x="7050594" y="5331753"/>
            <a:ext cx="9427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otto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ob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s p2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0E76C91-E47D-5424-33AE-ED5013FA4D74}"/>
              </a:ext>
            </a:extLst>
          </p:cNvPr>
          <p:cNvSpPr txBox="1"/>
          <p:nvPr/>
        </p:nvSpPr>
        <p:spPr>
          <a:xfrm flipH="1">
            <a:off x="7020799" y="3675177"/>
            <a:ext cx="9427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ottom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-4EBP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5DF1477-4855-457E-18DC-B98122E9554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049"/>
          <a:stretch/>
        </p:blipFill>
        <p:spPr>
          <a:xfrm>
            <a:off x="940183" y="1702489"/>
            <a:ext cx="5009763" cy="13906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ED6A84E-85CE-C1BB-0A1B-9158BDA6CF0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12003" y="3621016"/>
            <a:ext cx="4076700" cy="15430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E3F9A706-2AA0-1023-3487-002A2B8C79E1}"/>
              </a:ext>
            </a:extLst>
          </p:cNvPr>
          <p:cNvSpPr/>
          <p:nvPr/>
        </p:nvSpPr>
        <p:spPr>
          <a:xfrm>
            <a:off x="317485" y="1505000"/>
            <a:ext cx="5841079" cy="4852416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DED8EEF4-4D36-943E-24AC-64A65E4C9817}"/>
              </a:ext>
            </a:extLst>
          </p:cNvPr>
          <p:cNvSpPr/>
          <p:nvPr/>
        </p:nvSpPr>
        <p:spPr>
          <a:xfrm>
            <a:off x="6750453" y="942562"/>
            <a:ext cx="5953611" cy="5830093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2781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83BFE2-37A2-DF64-BE1C-AFE1AF1056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Figure 2c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68CB3BF-0D56-A226-9683-4176698A768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90" t="-4834" r="23967" b="1"/>
          <a:stretch/>
        </p:blipFill>
        <p:spPr>
          <a:xfrm>
            <a:off x="1023598" y="1727763"/>
            <a:ext cx="4705351" cy="176548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B7D0488-D023-8F7F-60AB-E977CBAED32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7716"/>
          <a:stretch/>
        </p:blipFill>
        <p:spPr>
          <a:xfrm>
            <a:off x="954473" y="3592135"/>
            <a:ext cx="4843599" cy="13716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48233C0-9FEB-9868-ADBE-3366818763DB}"/>
              </a:ext>
            </a:extLst>
          </p:cNvPr>
          <p:cNvSpPr txBox="1"/>
          <p:nvPr/>
        </p:nvSpPr>
        <p:spPr>
          <a:xfrm flipH="1">
            <a:off x="396162" y="2967335"/>
            <a:ext cx="7130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-RB795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CD279AF-AB05-B3DD-5081-2051C4037519}"/>
              </a:ext>
            </a:extLst>
          </p:cNvPr>
          <p:cNvSpPr txBox="1"/>
          <p:nvPr/>
        </p:nvSpPr>
        <p:spPr>
          <a:xfrm flipH="1">
            <a:off x="378838" y="4506748"/>
            <a:ext cx="7952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ottom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7E47AD04-2B0B-20F0-2EA3-2D66010B52D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39512" y="4825365"/>
            <a:ext cx="5074820" cy="151447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115B691-C990-596B-456A-27FCAF19595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59430" y="1392081"/>
            <a:ext cx="5524500" cy="15240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20B5A56F-12F5-2A10-71B8-91ACB358257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69695" y="2929013"/>
            <a:ext cx="4781550" cy="151447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459FC73-309B-1EEE-A1C7-E5AF5B9F28FD}"/>
              </a:ext>
            </a:extLst>
          </p:cNvPr>
          <p:cNvSpPr/>
          <p:nvPr/>
        </p:nvSpPr>
        <p:spPr>
          <a:xfrm>
            <a:off x="254441" y="1487424"/>
            <a:ext cx="5808917" cy="3645408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CDCE846-6710-E38F-3DEE-7C391694B57B}"/>
              </a:ext>
            </a:extLst>
          </p:cNvPr>
          <p:cNvSpPr/>
          <p:nvPr/>
        </p:nvSpPr>
        <p:spPr>
          <a:xfrm>
            <a:off x="6205079" y="1487424"/>
            <a:ext cx="5808917" cy="4852416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30AE14D-D1C2-339D-1ED7-20D5C55F0384}"/>
              </a:ext>
            </a:extLst>
          </p:cNvPr>
          <p:cNvSpPr txBox="1"/>
          <p:nvPr/>
        </p:nvSpPr>
        <p:spPr>
          <a:xfrm flipH="1">
            <a:off x="6496724" y="5235086"/>
            <a:ext cx="9083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ottom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79D3814-347D-CE28-BBF4-9805623F9331}"/>
              </a:ext>
            </a:extLst>
          </p:cNvPr>
          <p:cNvSpPr txBox="1"/>
          <p:nvPr/>
        </p:nvSpPr>
        <p:spPr>
          <a:xfrm flipH="1">
            <a:off x="6517393" y="3604627"/>
            <a:ext cx="9722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β-actin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ob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64EDCA3-9C6D-7A81-CC30-48B9A4DE72EB}"/>
              </a:ext>
            </a:extLst>
          </p:cNvPr>
          <p:cNvSpPr txBox="1"/>
          <p:nvPr/>
        </p:nvSpPr>
        <p:spPr>
          <a:xfrm flipH="1">
            <a:off x="6453377" y="2225913"/>
            <a:ext cx="97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yclin E1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68750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400238-15D6-5F50-0B05-D339B97B72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7355" y="-181849"/>
            <a:ext cx="10515600" cy="1325563"/>
          </a:xfrm>
        </p:spPr>
        <p:txBody>
          <a:bodyPr>
            <a:normAutofit/>
          </a:bodyPr>
          <a:lstStyle/>
          <a:p>
            <a:r>
              <a:rPr lang="en-GB" sz="3000" dirty="0"/>
              <a:t>Figure 5d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3F91F44-D653-ADCB-E17E-B0CDA38833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9049" y="952034"/>
            <a:ext cx="4201904" cy="175408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FD1EFE4-05D0-73E6-C8CB-89755FAE8CF0}"/>
              </a:ext>
            </a:extLst>
          </p:cNvPr>
          <p:cNvSpPr txBox="1"/>
          <p:nvPr/>
        </p:nvSpPr>
        <p:spPr>
          <a:xfrm flipH="1">
            <a:off x="564359" y="1819119"/>
            <a:ext cx="7952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22B6822-D8C2-4C7E-0577-21D6FB1B3AB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2558" y="2922698"/>
            <a:ext cx="4122755" cy="160245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ABAFED3-F85E-937D-BF1A-426B2494BEAD}"/>
              </a:ext>
            </a:extLst>
          </p:cNvPr>
          <p:cNvSpPr txBox="1"/>
          <p:nvPr/>
        </p:nvSpPr>
        <p:spPr>
          <a:xfrm flipH="1">
            <a:off x="564358" y="3446927"/>
            <a:ext cx="7952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CI-H23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89E5B2B-F4F5-D7D8-FB38-FA8920A0FC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57731" y="4639831"/>
            <a:ext cx="3903262" cy="203503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3056E198-AD22-78BC-794F-8A462040D638}"/>
              </a:ext>
            </a:extLst>
          </p:cNvPr>
          <p:cNvSpPr txBox="1"/>
          <p:nvPr/>
        </p:nvSpPr>
        <p:spPr>
          <a:xfrm flipH="1">
            <a:off x="607355" y="5297588"/>
            <a:ext cx="1150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DA-MB-436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FBF5F6D1-25EE-269A-1F70-B291A165C5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0358" y="1079904"/>
            <a:ext cx="4442085" cy="555040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2D76895-7461-2908-C231-4E8B703568BF}"/>
              </a:ext>
            </a:extLst>
          </p:cNvPr>
          <p:cNvSpPr txBox="1"/>
          <p:nvPr/>
        </p:nvSpPr>
        <p:spPr>
          <a:xfrm flipH="1">
            <a:off x="6864521" y="689115"/>
            <a:ext cx="865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ob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s β-actin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3141B3F-8815-74DC-EF18-568218F9B52F}"/>
              </a:ext>
            </a:extLst>
          </p:cNvPr>
          <p:cNvSpPr/>
          <p:nvPr/>
        </p:nvSpPr>
        <p:spPr>
          <a:xfrm>
            <a:off x="3087424" y="689113"/>
            <a:ext cx="643467" cy="5941196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F246CD8F-9874-7637-D683-97AE9D118566}"/>
              </a:ext>
            </a:extLst>
          </p:cNvPr>
          <p:cNvSpPr/>
          <p:nvPr/>
        </p:nvSpPr>
        <p:spPr>
          <a:xfrm>
            <a:off x="8337210" y="644732"/>
            <a:ext cx="643467" cy="5941196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6C7D8D9-00E1-60EA-059E-BFF85E29C5EE}"/>
              </a:ext>
            </a:extLst>
          </p:cNvPr>
          <p:cNvSpPr txBox="1"/>
          <p:nvPr/>
        </p:nvSpPr>
        <p:spPr>
          <a:xfrm flipH="1">
            <a:off x="478963" y="910422"/>
            <a:ext cx="8652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OD2</a:t>
            </a:r>
            <a:endParaRPr lang="en-I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9343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F93797C-2F97-0FD6-A1DE-4FC4E65CF9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01989" y="1533435"/>
            <a:ext cx="3618108" cy="156383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6552CB7-5977-0B32-15B3-ACA5EBE9B0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1956" y="1385379"/>
            <a:ext cx="4181662" cy="524493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5BEA5E2-66CB-B185-17FE-35516459E8A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69224" y="3199771"/>
            <a:ext cx="3739132" cy="161614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EDF7C5D-4EA5-151E-E018-27457F78B7D7}"/>
              </a:ext>
            </a:extLst>
          </p:cNvPr>
          <p:cNvSpPr txBox="1"/>
          <p:nvPr/>
        </p:nvSpPr>
        <p:spPr>
          <a:xfrm flipH="1">
            <a:off x="564359" y="1819119"/>
            <a:ext cx="7952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5CBFCFC-4016-7A0C-5ABE-439E3D26A827}"/>
              </a:ext>
            </a:extLst>
          </p:cNvPr>
          <p:cNvSpPr txBox="1"/>
          <p:nvPr/>
        </p:nvSpPr>
        <p:spPr>
          <a:xfrm flipH="1">
            <a:off x="564358" y="3446927"/>
            <a:ext cx="7952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CI-H23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58879FA-FCB1-9D0D-1BD9-4853F19FCAE0}"/>
              </a:ext>
            </a:extLst>
          </p:cNvPr>
          <p:cNvSpPr txBox="1"/>
          <p:nvPr/>
        </p:nvSpPr>
        <p:spPr>
          <a:xfrm flipH="1">
            <a:off x="507269" y="5195622"/>
            <a:ext cx="1172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DA-MB-436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88E6A1F1-546B-9981-012B-6699425FCD9A}"/>
              </a:ext>
            </a:extLst>
          </p:cNvPr>
          <p:cNvSpPr/>
          <p:nvPr/>
        </p:nvSpPr>
        <p:spPr>
          <a:xfrm>
            <a:off x="3289128" y="689113"/>
            <a:ext cx="515970" cy="5941196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3B3F202C-4A40-AC31-14FA-8B73AB4DEA0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75927" y="5153307"/>
            <a:ext cx="3490428" cy="1477002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6205AF3F-7B05-E319-0096-77203161C93A}"/>
              </a:ext>
            </a:extLst>
          </p:cNvPr>
          <p:cNvSpPr/>
          <p:nvPr/>
        </p:nvSpPr>
        <p:spPr>
          <a:xfrm>
            <a:off x="8014307" y="667507"/>
            <a:ext cx="515970" cy="5941196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21666D6-5DC9-57EA-B5A1-19A7C0FBEBED}"/>
              </a:ext>
            </a:extLst>
          </p:cNvPr>
          <p:cNvSpPr txBox="1"/>
          <p:nvPr/>
        </p:nvSpPr>
        <p:spPr>
          <a:xfrm flipH="1">
            <a:off x="6180216" y="773577"/>
            <a:ext cx="8652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eprob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s β-actin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6DFA4C7-6896-C966-81D6-509E1259A7FC}"/>
              </a:ext>
            </a:extLst>
          </p:cNvPr>
          <p:cNvSpPr txBox="1"/>
          <p:nvPr/>
        </p:nvSpPr>
        <p:spPr>
          <a:xfrm flipH="1">
            <a:off x="478963" y="910422"/>
            <a:ext cx="8652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en-IN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E442C2EA-B71E-23C1-6341-22CFEA5A1F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7355" y="-181849"/>
            <a:ext cx="10515600" cy="1325563"/>
          </a:xfrm>
        </p:spPr>
        <p:txBody>
          <a:bodyPr>
            <a:normAutofit/>
          </a:bodyPr>
          <a:lstStyle/>
          <a:p>
            <a:r>
              <a:rPr lang="en-GB" sz="3000" dirty="0"/>
              <a:t>Figure 5d</a:t>
            </a:r>
          </a:p>
        </p:txBody>
      </p:sp>
    </p:spTree>
    <p:extLst>
      <p:ext uri="{BB962C8B-B14F-4D97-AF65-F5344CB8AC3E}">
        <p14:creationId xmlns:p14="http://schemas.microsoft.com/office/powerpoint/2010/main" val="3820156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27</TotalTime>
  <Words>72</Words>
  <Application>Microsoft Office PowerPoint</Application>
  <PresentationFormat>Custom</PresentationFormat>
  <Paragraphs>45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Western blots (uncut)</vt:lpstr>
      <vt:lpstr>Figure 3d</vt:lpstr>
      <vt:lpstr>Figure 3b</vt:lpstr>
      <vt:lpstr>Figure 2c</vt:lpstr>
      <vt:lpstr>Figure 5d</vt:lpstr>
      <vt:lpstr>Figure 5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ren Yalaz</dc:creator>
  <cp:lastModifiedBy>Ceren Yalaz</cp:lastModifiedBy>
  <cp:revision>56</cp:revision>
  <dcterms:created xsi:type="dcterms:W3CDTF">2023-09-16T15:04:14Z</dcterms:created>
  <dcterms:modified xsi:type="dcterms:W3CDTF">2023-09-18T15:19:24Z</dcterms:modified>
</cp:coreProperties>
</file>